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7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1672" y="1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486FA-3EFE-4452-BA44-5FBB8EC81E32}" type="datetimeFigureOut">
              <a:rPr lang="it-IT" smtClean="0"/>
              <a:t>21/01/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D3F33-8C08-489C-91B2-587903FAFDA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555289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486FA-3EFE-4452-BA44-5FBB8EC81E32}" type="datetimeFigureOut">
              <a:rPr lang="it-IT" smtClean="0"/>
              <a:t>21/01/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D3F33-8C08-489C-91B2-587903FAFDA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329244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486FA-3EFE-4452-BA44-5FBB8EC81E32}" type="datetimeFigureOut">
              <a:rPr lang="it-IT" smtClean="0"/>
              <a:t>21/01/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D3F33-8C08-489C-91B2-587903FAFDA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701818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486FA-3EFE-4452-BA44-5FBB8EC81E32}" type="datetimeFigureOut">
              <a:rPr lang="it-IT" smtClean="0"/>
              <a:t>21/01/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D3F33-8C08-489C-91B2-587903FAFDA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40795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486FA-3EFE-4452-BA44-5FBB8EC81E32}" type="datetimeFigureOut">
              <a:rPr lang="it-IT" smtClean="0"/>
              <a:t>21/01/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D3F33-8C08-489C-91B2-587903FAFDA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778665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486FA-3EFE-4452-BA44-5FBB8EC81E32}" type="datetimeFigureOut">
              <a:rPr lang="it-IT" smtClean="0"/>
              <a:t>21/01/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D3F33-8C08-489C-91B2-587903FAFDA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387337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486FA-3EFE-4452-BA44-5FBB8EC81E32}" type="datetimeFigureOut">
              <a:rPr lang="it-IT" smtClean="0"/>
              <a:t>21/01/20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D3F33-8C08-489C-91B2-587903FAFDA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300466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486FA-3EFE-4452-BA44-5FBB8EC81E32}" type="datetimeFigureOut">
              <a:rPr lang="it-IT" smtClean="0"/>
              <a:t>21/01/20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D3F33-8C08-489C-91B2-587903FAFDA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783190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486FA-3EFE-4452-BA44-5FBB8EC81E32}" type="datetimeFigureOut">
              <a:rPr lang="it-IT" smtClean="0"/>
              <a:t>21/01/20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D3F33-8C08-489C-91B2-587903FAFDA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566512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486FA-3EFE-4452-BA44-5FBB8EC81E32}" type="datetimeFigureOut">
              <a:rPr lang="it-IT" smtClean="0"/>
              <a:t>21/01/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D3F33-8C08-489C-91B2-587903FAFDA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803374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486FA-3EFE-4452-BA44-5FBB8EC81E32}" type="datetimeFigureOut">
              <a:rPr lang="it-IT" smtClean="0"/>
              <a:t>21/01/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D3F33-8C08-489C-91B2-587903FAFDA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780352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B486FA-3EFE-4452-BA44-5FBB8EC81E32}" type="datetimeFigureOut">
              <a:rPr lang="it-IT" smtClean="0"/>
              <a:t>21/01/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BD3F33-8C08-489C-91B2-587903FAFDA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02166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5911" y="645882"/>
            <a:ext cx="8432512" cy="6239751"/>
          </a:xfrm>
          <a:prstGeom prst="rect">
            <a:avLst/>
          </a:prstGeom>
        </p:spPr>
      </p:pic>
      <p:sp>
        <p:nvSpPr>
          <p:cNvPr id="5" name="CasellaDiTesto 4"/>
          <p:cNvSpPr txBox="1"/>
          <p:nvPr/>
        </p:nvSpPr>
        <p:spPr>
          <a:xfrm>
            <a:off x="175911" y="130629"/>
            <a:ext cx="89680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it-IT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</a:t>
            </a:r>
            <a:r>
              <a:rPr lang="it-IT" sz="1600">
                <a:latin typeface="Times New Roman" panose="02020603050405020304" pitchFamily="18" charset="0"/>
                <a:cs typeface="Times New Roman" panose="02020603050405020304" pitchFamily="18" charset="0"/>
              </a:rPr>
              <a:t> S7. </a:t>
            </a:r>
            <a:r>
              <a:rPr lang="it-IT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 </a:t>
            </a:r>
            <a:r>
              <a:rPr lang="it-IT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</a:t>
            </a:r>
            <a:r>
              <a:rPr lang="it-IT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ross</a:t>
            </a:r>
            <a:r>
              <a:rPr lang="it-IT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12 </a:t>
            </a:r>
            <a:r>
              <a:rPr lang="it-IT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romosomes</a:t>
            </a:r>
            <a:r>
              <a:rPr lang="it-IT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the v4.0 </a:t>
            </a:r>
            <a:r>
              <a:rPr lang="it-IT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lon</a:t>
            </a:r>
            <a:r>
              <a:rPr lang="it-IT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nome</a:t>
            </a:r>
            <a:r>
              <a:rPr lang="it-IT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sembly</a:t>
            </a:r>
            <a:endParaRPr lang="it-IT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958280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9156" y="509450"/>
            <a:ext cx="9044844" cy="623107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0235332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16</Words>
  <Application>Microsoft Macintosh PowerPoint</Application>
  <PresentationFormat>On-screen Show (4:3)</PresentationFormat>
  <Paragraphs>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ema di Offic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Utente Windows</dc:creator>
  <cp:lastModifiedBy>Raúl Castanera Andrés</cp:lastModifiedBy>
  <cp:revision>5</cp:revision>
  <dcterms:created xsi:type="dcterms:W3CDTF">2019-06-25T18:40:27Z</dcterms:created>
  <dcterms:modified xsi:type="dcterms:W3CDTF">2020-01-21T13:59:50Z</dcterms:modified>
</cp:coreProperties>
</file>